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hawn Vahabzadeh, PharmD (MTM)" initials="SVP(" lastIdx="10" clrIdx="0">
    <p:extLst>
      <p:ext uri="{19B8F6BF-5375-455C-9EA6-DF929625EA0E}">
        <p15:presenceInfo xmlns:p15="http://schemas.microsoft.com/office/powerpoint/2012/main" userId="S-1-5-21-2754625900-2601979746-2412578218-11731" providerId="AD"/>
      </p:ext>
    </p:extLst>
  </p:cmAuthor>
  <p:cmAuthor id="2" name="Shawn Vahabzadeh, PharmD (MTM)" initials="SVP( [2]" lastIdx="16" clrIdx="1">
    <p:extLst>
      <p:ext uri="{19B8F6BF-5375-455C-9EA6-DF929625EA0E}">
        <p15:presenceInfo xmlns:p15="http://schemas.microsoft.com/office/powerpoint/2012/main" userId="S::Shawn.Vahabzadeh@meditechmedia.com::8407814f-7d61-4076-90b4-a45247fb421d" providerId="AD"/>
      </p:ext>
    </p:extLst>
  </p:cmAuthor>
  <p:cmAuthor id="3" name="Mihaela Marina, PhD (MTM)" initials="MMP(" lastIdx="2" clrIdx="2">
    <p:extLst>
      <p:ext uri="{19B8F6BF-5375-455C-9EA6-DF929625EA0E}">
        <p15:presenceInfo xmlns:p15="http://schemas.microsoft.com/office/powerpoint/2012/main" userId="S::Mihaela.Marina@meditechmedia.com::7d92716a-fcf1-4ee5-8b29-5c80102b01ec" providerId="AD"/>
      </p:ext>
    </p:extLst>
  </p:cmAuthor>
  <p:cmAuthor id="4" name="Kerry Garza, PhD (MTM)" initials="KGP(" lastIdx="1" clrIdx="3">
    <p:extLst>
      <p:ext uri="{19B8F6BF-5375-455C-9EA6-DF929625EA0E}">
        <p15:presenceInfo xmlns:p15="http://schemas.microsoft.com/office/powerpoint/2012/main" userId="S::Kerry.Garza@meditechmedia.com::f4e76a70-b598-4fb8-9249-00fb37dcbcf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>
        <p:scale>
          <a:sx n="125" d="100"/>
          <a:sy n="125" d="100"/>
        </p:scale>
        <p:origin x="-1608" y="8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CF7B04-DB20-4F80-BC0B-BE73FC1FF19B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E4D31DB-BDA9-4411-A6B4-DA8E30374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4022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D0F2F8-8EDC-49FC-8241-ED911DEA466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F274BE0-9E6C-4E16-8737-26911C16BF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779BA7-1D7E-4FC7-9802-232CC18B62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076F9E-C824-4E91-9540-C0F604E9A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CFB0A0-82A8-44F2-91B1-0E3DC0077D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3522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E2BC04-51C1-4C7A-B0C9-3B29161D3A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C3DB4C4-BD54-4A84-87C9-74E7EBB719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FB588C-B6BE-4CD1-AC13-BD5068F315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D7306C-A1A6-4443-9800-FDBF53C319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E52C82-C0C4-439B-AB00-730BE60346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4454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7F834FF-4EBD-4FAB-955A-6295CED360E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8A6C2CF-15DE-4302-9BCF-4D12EF2DBD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F13713-FEBC-45BA-9BE1-F33222BD3E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DD4430-032A-4ED7-9DE4-22ED13BFE3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B55C2B-6700-4193-99E2-28DC04B50F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2155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50AD3A-FEED-4E19-9E35-132E1EA023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7342AF-3B19-4EC3-91A7-DDA84EDCAD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A448CE-73F9-47D3-96F8-81C8D79A7D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01B96F-E8A3-4B54-A0A4-60F4D0861D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056346-E2EC-4C8B-992F-F45993CFEE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4142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2A1035-750D-48CC-A966-C02C2C37D1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7356EE-F460-4CE2-8150-55B8019B87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F84991-69AD-4BEA-97E7-2398040BEF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1FF1DE-E32F-42EE-A098-EB728B73ED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9A45F1-8F16-45DB-8C7F-E580259B41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6479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C6FDAA-BD01-4A3C-9937-8B8EC440A0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7BB6C7-C538-4C9F-B38E-73EF5701055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A9D1F4F-0916-43DB-95A2-6E82D86170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B4D148-4AB4-4FB1-BFEC-FC894CFED4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9B4010-C9CD-486C-8C1C-85A86D4B0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F6E868-F1F2-43F1-AE00-4931C25C78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2063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44B9BD-3A56-4568-8D94-A56775B175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658F85-C64D-4B50-B2A4-0281864088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34E9A08-04DB-4AB6-8E11-68684487D8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E1DA1D6-6A0D-4565-AF93-2CD893EAF35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7751BBA-6380-4631-B09D-E04DF7CC48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AA0F4E2-3289-4180-9729-114937A9C1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0077B10-67B4-4B35-9E45-9DE9DF2163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93F01D2-0FDD-45A6-943D-98D039DC37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9744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EDB2D0-EC6E-4C14-B176-4B79FDA690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9DD6F7E-A9ED-4557-BB7E-E81DACB159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7281D85-1568-4F8B-A7AC-05387FE9EF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3922F02-18CF-4C31-A96D-69F74FC2B9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478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846232E-5ED5-4129-90C9-6C2E2F5040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3C44D1F-734B-41C7-8A28-C4F111053F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F2524A9-F1D0-4A52-84F4-882F6B9CD2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65074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36B691-ACA6-4739-894C-0AACBA40DC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7E00E4-CB86-441A-B7E2-9651EDBF95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EC724B-ADE1-456D-8641-6D2F07413B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66277A-028B-4F3B-B640-B79856C21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AE577F-B0AC-4EC1-8B5A-AB653D621D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3FDB6B-D020-457F-93E3-3A47CACDF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8101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913530-847B-4EA5-B525-826E900633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6670428-8077-484F-AF6A-A6DAD4AD55D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20FAE95-3E50-4529-9F33-A3F5F7FBA0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2EA920-0AE0-4FFF-B5BA-0F3C2FC6C2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1B7295-58FE-4167-82AD-5BDF1FA6B0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100CAF-FB30-42E6-9C8F-629A3D6989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54712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590FB55-2BED-4098-8A24-61DFF2047B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E1CC5D-E3B0-4B04-A475-B16B546E74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64E550-4BE0-4B41-A1B1-3DF5DFCAA23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A4B1B3-A1DD-4859-92C9-5673F9F03F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66C937-234E-4EF6-AC65-93D4C0B321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3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9" name="Group 148">
            <a:extLst>
              <a:ext uri="{FF2B5EF4-FFF2-40B4-BE49-F238E27FC236}">
                <a16:creationId xmlns:a16="http://schemas.microsoft.com/office/drawing/2014/main" id="{277B8D6B-564F-48D9-830F-18A7BCA8C3F0}"/>
              </a:ext>
            </a:extLst>
          </p:cNvPr>
          <p:cNvGrpSpPr/>
          <p:nvPr/>
        </p:nvGrpSpPr>
        <p:grpSpPr>
          <a:xfrm>
            <a:off x="3627438" y="1465580"/>
            <a:ext cx="5608638" cy="3116263"/>
            <a:chOff x="3627438" y="1549400"/>
            <a:chExt cx="5608638" cy="3116263"/>
          </a:xfrm>
        </p:grpSpPr>
        <p:sp>
          <p:nvSpPr>
            <p:cNvPr id="8" name="Line 5">
              <a:extLst>
                <a:ext uri="{FF2B5EF4-FFF2-40B4-BE49-F238E27FC236}">
                  <a16:creationId xmlns:a16="http://schemas.microsoft.com/office/drawing/2014/main" id="{9D42354F-3EDE-430E-B237-9D9A5A5CFF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681413" y="3076575"/>
              <a:ext cx="5554663" cy="0"/>
            </a:xfrm>
            <a:prstGeom prst="line">
              <a:avLst/>
            </a:prstGeom>
            <a:noFill/>
            <a:ln w="14351" cap="flat">
              <a:solidFill>
                <a:schemeClr val="tx1"/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148" name="Group 147">
              <a:extLst>
                <a:ext uri="{FF2B5EF4-FFF2-40B4-BE49-F238E27FC236}">
                  <a16:creationId xmlns:a16="http://schemas.microsoft.com/office/drawing/2014/main" id="{CBA9E04F-14D6-416F-8EC9-AFB933F01B9F}"/>
                </a:ext>
              </a:extLst>
            </p:cNvPr>
            <p:cNvGrpSpPr/>
            <p:nvPr/>
          </p:nvGrpSpPr>
          <p:grpSpPr>
            <a:xfrm>
              <a:off x="3627438" y="1549400"/>
              <a:ext cx="5608638" cy="3116263"/>
              <a:chOff x="3627438" y="1549400"/>
              <a:chExt cx="5608638" cy="3116263"/>
            </a:xfrm>
          </p:grpSpPr>
          <p:sp>
            <p:nvSpPr>
              <p:cNvPr id="9" name="Line 6">
                <a:extLst>
                  <a:ext uri="{FF2B5EF4-FFF2-40B4-BE49-F238E27FC236}">
                    <a16:creationId xmlns:a16="http://schemas.microsoft.com/office/drawing/2014/main" id="{1F2B1283-4661-47DC-A3B9-2831B249F2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27438" y="4548188"/>
                <a:ext cx="53975" cy="0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" name="Line 7">
                <a:extLst>
                  <a:ext uri="{FF2B5EF4-FFF2-40B4-BE49-F238E27FC236}">
                    <a16:creationId xmlns:a16="http://schemas.microsoft.com/office/drawing/2014/main" id="{9ECE9C70-D560-4DCC-90D0-F42B2DBFDC4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27438" y="3962400"/>
                <a:ext cx="53975" cy="0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" name="Line 8">
                <a:extLst>
                  <a:ext uri="{FF2B5EF4-FFF2-40B4-BE49-F238E27FC236}">
                    <a16:creationId xmlns:a16="http://schemas.microsoft.com/office/drawing/2014/main" id="{B38B3981-0B0F-4A08-9B99-4BF0BE40E0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27438" y="3376613"/>
                <a:ext cx="53975" cy="0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" name="Line 9">
                <a:extLst>
                  <a:ext uri="{FF2B5EF4-FFF2-40B4-BE49-F238E27FC236}">
                    <a16:creationId xmlns:a16="http://schemas.microsoft.com/office/drawing/2014/main" id="{1DC1D0B5-45C6-4C09-850F-B2DAC4AF28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27438" y="2784475"/>
                <a:ext cx="53975" cy="0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" name="Line 10">
                <a:extLst>
                  <a:ext uri="{FF2B5EF4-FFF2-40B4-BE49-F238E27FC236}">
                    <a16:creationId xmlns:a16="http://schemas.microsoft.com/office/drawing/2014/main" id="{4C86F4D3-2CB3-4DD0-AB38-F7724BA140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27438" y="2195513"/>
                <a:ext cx="53975" cy="0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" name="Line 11">
                <a:extLst>
                  <a:ext uri="{FF2B5EF4-FFF2-40B4-BE49-F238E27FC236}">
                    <a16:creationId xmlns:a16="http://schemas.microsoft.com/office/drawing/2014/main" id="{D926F103-0077-41AA-8DE9-1B97AD301D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27438" y="1609725"/>
                <a:ext cx="53975" cy="0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" name="Line 18">
                <a:extLst>
                  <a:ext uri="{FF2B5EF4-FFF2-40B4-BE49-F238E27FC236}">
                    <a16:creationId xmlns:a16="http://schemas.microsoft.com/office/drawing/2014/main" id="{A591EDA5-8682-44CC-8C89-30E06349CE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02063" y="4611688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" name="Line 19">
                <a:extLst>
                  <a:ext uri="{FF2B5EF4-FFF2-40B4-BE49-F238E27FC236}">
                    <a16:creationId xmlns:a16="http://schemas.microsoft.com/office/drawing/2014/main" id="{CA101A30-0026-4451-9132-C3FDE93AD1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83063" y="4611688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" name="Line 20">
                <a:extLst>
                  <a:ext uri="{FF2B5EF4-FFF2-40B4-BE49-F238E27FC236}">
                    <a16:creationId xmlns:a16="http://schemas.microsoft.com/office/drawing/2014/main" id="{6947B087-D18B-42F1-BABC-22247AEA53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60888" y="4611688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" name="Line 21">
                <a:extLst>
                  <a:ext uri="{FF2B5EF4-FFF2-40B4-BE49-F238E27FC236}">
                    <a16:creationId xmlns:a16="http://schemas.microsoft.com/office/drawing/2014/main" id="{EAC0849B-3DBB-4791-B04B-3AF2265163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40300" y="4611688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" name="Line 22">
                <a:extLst>
                  <a:ext uri="{FF2B5EF4-FFF2-40B4-BE49-F238E27FC236}">
                    <a16:creationId xmlns:a16="http://schemas.microsoft.com/office/drawing/2014/main" id="{FAB0EAD4-EFD7-487A-882A-AE683AFE2E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321300" y="4611688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" name="Line 23">
                <a:extLst>
                  <a:ext uri="{FF2B5EF4-FFF2-40B4-BE49-F238E27FC236}">
                    <a16:creationId xmlns:a16="http://schemas.microsoft.com/office/drawing/2014/main" id="{482F059D-2FC9-4378-80CC-F2C2D35471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00713" y="4611688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" name="Line 24">
                <a:extLst>
                  <a:ext uri="{FF2B5EF4-FFF2-40B4-BE49-F238E27FC236}">
                    <a16:creationId xmlns:a16="http://schemas.microsoft.com/office/drawing/2014/main" id="{AC2ACA62-F4A6-46F6-AC28-63398D33E9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078538" y="4611688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" name="Line 25">
                <a:extLst>
                  <a:ext uri="{FF2B5EF4-FFF2-40B4-BE49-F238E27FC236}">
                    <a16:creationId xmlns:a16="http://schemas.microsoft.com/office/drawing/2014/main" id="{6E54C041-F837-4755-9346-DC33E7C909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59538" y="4611688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" name="Line 26">
                <a:extLst>
                  <a:ext uri="{FF2B5EF4-FFF2-40B4-BE49-F238E27FC236}">
                    <a16:creationId xmlns:a16="http://schemas.microsoft.com/office/drawing/2014/main" id="{E3C049F7-5FA8-4590-B500-DC23F32EA79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38950" y="4611688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0" name="Line 27">
                <a:extLst>
                  <a:ext uri="{FF2B5EF4-FFF2-40B4-BE49-F238E27FC236}">
                    <a16:creationId xmlns:a16="http://schemas.microsoft.com/office/drawing/2014/main" id="{80586C26-2612-44BB-B6B6-5E0300D403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16775" y="4611688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1" name="Line 28">
                <a:extLst>
                  <a:ext uri="{FF2B5EF4-FFF2-40B4-BE49-F238E27FC236}">
                    <a16:creationId xmlns:a16="http://schemas.microsoft.com/office/drawing/2014/main" id="{4E563A94-4B9D-432D-A891-6E9C553C14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97775" y="4611688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" name="Line 29">
                <a:extLst>
                  <a:ext uri="{FF2B5EF4-FFF2-40B4-BE49-F238E27FC236}">
                    <a16:creationId xmlns:a16="http://schemas.microsoft.com/office/drawing/2014/main" id="{114AB65C-D0DC-4AE2-8EE1-F381FD4F0A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977188" y="4611688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" name="Line 30">
                <a:extLst>
                  <a:ext uri="{FF2B5EF4-FFF2-40B4-BE49-F238E27FC236}">
                    <a16:creationId xmlns:a16="http://schemas.microsoft.com/office/drawing/2014/main" id="{2EEA0154-4E2B-4D16-A75E-0EF93BE4DC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55013" y="4611688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" name="Line 31">
                <a:extLst>
                  <a:ext uri="{FF2B5EF4-FFF2-40B4-BE49-F238E27FC236}">
                    <a16:creationId xmlns:a16="http://schemas.microsoft.com/office/drawing/2014/main" id="{BF1932D9-0292-4147-A206-67857D615D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732838" y="4611688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" name="Line 32">
                <a:extLst>
                  <a:ext uri="{FF2B5EF4-FFF2-40B4-BE49-F238E27FC236}">
                    <a16:creationId xmlns:a16="http://schemas.microsoft.com/office/drawing/2014/main" id="{29E4D51C-0824-48A5-8B30-B260F078A5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115425" y="4611688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0" name="Line 67">
                <a:extLst>
                  <a:ext uri="{FF2B5EF4-FFF2-40B4-BE49-F238E27FC236}">
                    <a16:creationId xmlns:a16="http://schemas.microsoft.com/office/drawing/2014/main" id="{658F5C61-4860-46A4-821A-783A0FAE4F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81413" y="4605338"/>
                <a:ext cx="5554663" cy="0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1" name="Line 68">
                <a:extLst>
                  <a:ext uri="{FF2B5EF4-FFF2-40B4-BE49-F238E27FC236}">
                    <a16:creationId xmlns:a16="http://schemas.microsoft.com/office/drawing/2014/main" id="{00B5D8BD-B094-4E2B-ADF2-57EB2D9041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81413" y="1549400"/>
                <a:ext cx="0" cy="3055938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</p:grpSp>
      <p:sp>
        <p:nvSpPr>
          <p:cNvPr id="15" name="Rectangle 12">
            <a:extLst>
              <a:ext uri="{FF2B5EF4-FFF2-40B4-BE49-F238E27FC236}">
                <a16:creationId xmlns:a16="http://schemas.microsoft.com/office/drawing/2014/main" id="{85967177-CEF8-4CEA-88CA-E55F6BF0E7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03410" y="4379440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0</a:t>
            </a:r>
          </a:p>
        </p:txBody>
      </p:sp>
      <p:sp>
        <p:nvSpPr>
          <p:cNvPr id="16" name="Rectangle 13">
            <a:extLst>
              <a:ext uri="{FF2B5EF4-FFF2-40B4-BE49-F238E27FC236}">
                <a16:creationId xmlns:a16="http://schemas.microsoft.com/office/drawing/2014/main" id="{9D0244EA-7ED5-4500-8B2C-5D35A4BEE7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9072" y="3784127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0</a:t>
            </a:r>
          </a:p>
        </p:txBody>
      </p:sp>
      <p:sp>
        <p:nvSpPr>
          <p:cNvPr id="17" name="Rectangle 14">
            <a:extLst>
              <a:ext uri="{FF2B5EF4-FFF2-40B4-BE49-F238E27FC236}">
                <a16:creationId xmlns:a16="http://schemas.microsoft.com/office/drawing/2014/main" id="{A6CDF0D9-31CB-40BB-AF4F-266E85AE7B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9072" y="3198340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40</a:t>
            </a:r>
          </a:p>
        </p:txBody>
      </p:sp>
      <p:sp>
        <p:nvSpPr>
          <p:cNvPr id="18" name="Rectangle 15">
            <a:extLst>
              <a:ext uri="{FF2B5EF4-FFF2-40B4-BE49-F238E27FC236}">
                <a16:creationId xmlns:a16="http://schemas.microsoft.com/office/drawing/2014/main" id="{6C582497-7374-4F5E-A051-03F58A49F2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9072" y="2612552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60</a:t>
            </a:r>
          </a:p>
        </p:txBody>
      </p:sp>
      <p:sp>
        <p:nvSpPr>
          <p:cNvPr id="19" name="Rectangle 16">
            <a:extLst>
              <a:ext uri="{FF2B5EF4-FFF2-40B4-BE49-F238E27FC236}">
                <a16:creationId xmlns:a16="http://schemas.microsoft.com/office/drawing/2014/main" id="{7B6A3FCA-CDDB-4A3A-998C-E6972F487F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9072" y="2017240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80</a:t>
            </a:r>
          </a:p>
        </p:txBody>
      </p:sp>
      <p:sp>
        <p:nvSpPr>
          <p:cNvPr id="20" name="Rectangle 17">
            <a:extLst>
              <a:ext uri="{FF2B5EF4-FFF2-40B4-BE49-F238E27FC236}">
                <a16:creationId xmlns:a16="http://schemas.microsoft.com/office/drawing/2014/main" id="{2CF85F0C-37B3-47E9-A327-69D8EF76A0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34732" y="1431452"/>
            <a:ext cx="2548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00</a:t>
            </a:r>
          </a:p>
        </p:txBody>
      </p:sp>
      <p:sp>
        <p:nvSpPr>
          <p:cNvPr id="38" name="Rectangle 35">
            <a:extLst>
              <a:ext uri="{FF2B5EF4-FFF2-40B4-BE49-F238E27FC236}">
                <a16:creationId xmlns:a16="http://schemas.microsoft.com/office/drawing/2014/main" id="{91F288C6-C5EB-402D-AFA2-29024D13D5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59893" y="4616768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0</a:t>
            </a:r>
          </a:p>
        </p:txBody>
      </p:sp>
      <p:sp>
        <p:nvSpPr>
          <p:cNvPr id="39" name="Rectangle 36">
            <a:extLst>
              <a:ext uri="{FF2B5EF4-FFF2-40B4-BE49-F238E27FC236}">
                <a16:creationId xmlns:a16="http://schemas.microsoft.com/office/drawing/2014/main" id="{55BCDED3-8BE8-465C-8E80-400C154A96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7718" y="4616768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</a:t>
            </a:r>
          </a:p>
        </p:txBody>
      </p:sp>
      <p:sp>
        <p:nvSpPr>
          <p:cNvPr id="40" name="Rectangle 37">
            <a:extLst>
              <a:ext uri="{FF2B5EF4-FFF2-40B4-BE49-F238E27FC236}">
                <a16:creationId xmlns:a16="http://schemas.microsoft.com/office/drawing/2014/main" id="{25B4BAA4-48E0-4C27-805E-65A144E0D8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15543" y="4616768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4</a:t>
            </a:r>
          </a:p>
        </p:txBody>
      </p:sp>
      <p:sp>
        <p:nvSpPr>
          <p:cNvPr id="41" name="Rectangle 38">
            <a:extLst>
              <a:ext uri="{FF2B5EF4-FFF2-40B4-BE49-F238E27FC236}">
                <a16:creationId xmlns:a16="http://schemas.microsoft.com/office/drawing/2014/main" id="{0F5F36B6-EB4F-4705-954E-3B3E0F0549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8130" y="4616768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6</a:t>
            </a:r>
          </a:p>
        </p:txBody>
      </p:sp>
      <p:sp>
        <p:nvSpPr>
          <p:cNvPr id="42" name="Rectangle 39">
            <a:extLst>
              <a:ext uri="{FF2B5EF4-FFF2-40B4-BE49-F238E27FC236}">
                <a16:creationId xmlns:a16="http://schemas.microsoft.com/office/drawing/2014/main" id="{EACC2E19-291E-4BD1-A2FE-87EAAF31DD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75955" y="4616768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8</a:t>
            </a:r>
          </a:p>
        </p:txBody>
      </p:sp>
      <p:sp>
        <p:nvSpPr>
          <p:cNvPr id="43" name="Rectangle 40">
            <a:extLst>
              <a:ext uri="{FF2B5EF4-FFF2-40B4-BE49-F238E27FC236}">
                <a16:creationId xmlns:a16="http://schemas.microsoft.com/office/drawing/2014/main" id="{871FEAD6-20CA-4C44-B5AE-43BA9EA22E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1611" y="4616768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0</a:t>
            </a:r>
          </a:p>
        </p:txBody>
      </p:sp>
      <p:sp>
        <p:nvSpPr>
          <p:cNvPr id="44" name="Rectangle 41">
            <a:extLst>
              <a:ext uri="{FF2B5EF4-FFF2-40B4-BE49-F238E27FC236}">
                <a16:creationId xmlns:a16="http://schemas.microsoft.com/office/drawing/2014/main" id="{BCCED4FE-AB19-41A1-ABC1-D8FD3320FC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94199" y="4616768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2</a:t>
            </a:r>
          </a:p>
        </p:txBody>
      </p:sp>
      <p:sp>
        <p:nvSpPr>
          <p:cNvPr id="45" name="Rectangle 42">
            <a:extLst>
              <a:ext uri="{FF2B5EF4-FFF2-40B4-BE49-F238E27FC236}">
                <a16:creationId xmlns:a16="http://schemas.microsoft.com/office/drawing/2014/main" id="{3240EFCB-7840-4F90-9FD7-2E78FFF9E9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2024" y="4616768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4</a:t>
            </a:r>
          </a:p>
        </p:txBody>
      </p:sp>
      <p:sp>
        <p:nvSpPr>
          <p:cNvPr id="46" name="Rectangle 43">
            <a:extLst>
              <a:ext uri="{FF2B5EF4-FFF2-40B4-BE49-F238E27FC236}">
                <a16:creationId xmlns:a16="http://schemas.microsoft.com/office/drawing/2014/main" id="{3A23C766-88DD-46F4-A624-E2D2987D46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51436" y="4616768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6</a:t>
            </a:r>
          </a:p>
        </p:txBody>
      </p:sp>
      <p:sp>
        <p:nvSpPr>
          <p:cNvPr id="47" name="Rectangle 44">
            <a:extLst>
              <a:ext uri="{FF2B5EF4-FFF2-40B4-BE49-F238E27FC236}">
                <a16:creationId xmlns:a16="http://schemas.microsoft.com/office/drawing/2014/main" id="{2943867C-3F33-46AE-B1BD-FC734ADA2C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32436" y="4616768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8</a:t>
            </a:r>
          </a:p>
        </p:txBody>
      </p:sp>
      <p:sp>
        <p:nvSpPr>
          <p:cNvPr id="48" name="Rectangle 45">
            <a:extLst>
              <a:ext uri="{FF2B5EF4-FFF2-40B4-BE49-F238E27FC236}">
                <a16:creationId xmlns:a16="http://schemas.microsoft.com/office/drawing/2014/main" id="{D031EEE5-7757-40D2-9768-48FEC130B5B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10261" y="4616768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0</a:t>
            </a:r>
          </a:p>
        </p:txBody>
      </p:sp>
      <p:sp>
        <p:nvSpPr>
          <p:cNvPr id="49" name="Rectangle 46">
            <a:extLst>
              <a:ext uri="{FF2B5EF4-FFF2-40B4-BE49-F238E27FC236}">
                <a16:creationId xmlns:a16="http://schemas.microsoft.com/office/drawing/2014/main" id="{613F9E86-F064-4AFA-B51A-E5EF3F4486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89674" y="4616768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2</a:t>
            </a:r>
          </a:p>
        </p:txBody>
      </p:sp>
      <p:sp>
        <p:nvSpPr>
          <p:cNvPr id="50" name="Rectangle 47">
            <a:extLst>
              <a:ext uri="{FF2B5EF4-FFF2-40B4-BE49-F238E27FC236}">
                <a16:creationId xmlns:a16="http://schemas.microsoft.com/office/drawing/2014/main" id="{A9204ED9-9F02-4194-903C-BDD5B4C8AD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70674" y="4616768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4</a:t>
            </a:r>
          </a:p>
        </p:txBody>
      </p:sp>
      <p:sp>
        <p:nvSpPr>
          <p:cNvPr id="51" name="Rectangle 48">
            <a:extLst>
              <a:ext uri="{FF2B5EF4-FFF2-40B4-BE49-F238E27FC236}">
                <a16:creationId xmlns:a16="http://schemas.microsoft.com/office/drawing/2014/main" id="{01D907D1-A885-4D3D-B362-11A1B762E3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48499" y="4616768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6</a:t>
            </a:r>
          </a:p>
        </p:txBody>
      </p:sp>
      <p:sp>
        <p:nvSpPr>
          <p:cNvPr id="52" name="Rectangle 49">
            <a:extLst>
              <a:ext uri="{FF2B5EF4-FFF2-40B4-BE49-F238E27FC236}">
                <a16:creationId xmlns:a16="http://schemas.microsoft.com/office/drawing/2014/main" id="{6D1307C3-AF91-4F01-B620-ABBEEEA1C6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27911" y="4616768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8</a:t>
            </a:r>
          </a:p>
        </p:txBody>
      </p:sp>
      <p:sp>
        <p:nvSpPr>
          <p:cNvPr id="53" name="Rectangle 50">
            <a:extLst>
              <a:ext uri="{FF2B5EF4-FFF2-40B4-BE49-F238E27FC236}">
                <a16:creationId xmlns:a16="http://schemas.microsoft.com/office/drawing/2014/main" id="{3C42A497-1E22-47FB-B194-04F8C8A996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17724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89</a:t>
            </a:r>
          </a:p>
        </p:txBody>
      </p:sp>
      <p:sp>
        <p:nvSpPr>
          <p:cNvPr id="54" name="Rectangle 51">
            <a:extLst>
              <a:ext uri="{FF2B5EF4-FFF2-40B4-BE49-F238E27FC236}">
                <a16:creationId xmlns:a16="http://schemas.microsoft.com/office/drawing/2014/main" id="{A7CC83AD-5FC3-4C36-B65B-14E6759332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5549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81</a:t>
            </a:r>
          </a:p>
        </p:txBody>
      </p:sp>
      <p:sp>
        <p:nvSpPr>
          <p:cNvPr id="55" name="Rectangle 52">
            <a:extLst>
              <a:ext uri="{FF2B5EF4-FFF2-40B4-BE49-F238E27FC236}">
                <a16:creationId xmlns:a16="http://schemas.microsoft.com/office/drawing/2014/main" id="{31989904-E7DB-4D37-9749-B330E78293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3374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73</a:t>
            </a:r>
          </a:p>
        </p:txBody>
      </p:sp>
      <p:sp>
        <p:nvSpPr>
          <p:cNvPr id="56" name="Rectangle 53">
            <a:extLst>
              <a:ext uri="{FF2B5EF4-FFF2-40B4-BE49-F238E27FC236}">
                <a16:creationId xmlns:a16="http://schemas.microsoft.com/office/drawing/2014/main" id="{11BE8885-84DC-4C83-BEEF-F7AABC1981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55961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69</a:t>
            </a:r>
          </a:p>
        </p:txBody>
      </p:sp>
      <p:sp>
        <p:nvSpPr>
          <p:cNvPr id="57" name="Rectangle 54">
            <a:extLst>
              <a:ext uri="{FF2B5EF4-FFF2-40B4-BE49-F238E27FC236}">
                <a16:creationId xmlns:a16="http://schemas.microsoft.com/office/drawing/2014/main" id="{AAE091C5-B409-49E3-B72B-8C7CE3C742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33786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64</a:t>
            </a:r>
          </a:p>
        </p:txBody>
      </p:sp>
      <p:sp>
        <p:nvSpPr>
          <p:cNvPr id="58" name="Rectangle 55">
            <a:extLst>
              <a:ext uri="{FF2B5EF4-FFF2-40B4-BE49-F238E27FC236}">
                <a16:creationId xmlns:a16="http://schemas.microsoft.com/office/drawing/2014/main" id="{283E04DA-5B0D-451B-827D-552F78D071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1611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59</a:t>
            </a:r>
          </a:p>
        </p:txBody>
      </p:sp>
      <p:sp>
        <p:nvSpPr>
          <p:cNvPr id="59" name="Rectangle 56">
            <a:extLst>
              <a:ext uri="{FF2B5EF4-FFF2-40B4-BE49-F238E27FC236}">
                <a16:creationId xmlns:a16="http://schemas.microsoft.com/office/drawing/2014/main" id="{59E31BDC-C847-4070-8BF7-F44A80DD7C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94199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53</a:t>
            </a:r>
          </a:p>
        </p:txBody>
      </p:sp>
      <p:sp>
        <p:nvSpPr>
          <p:cNvPr id="60" name="Rectangle 57">
            <a:extLst>
              <a:ext uri="{FF2B5EF4-FFF2-40B4-BE49-F238E27FC236}">
                <a16:creationId xmlns:a16="http://schemas.microsoft.com/office/drawing/2014/main" id="{192D5CAA-24B0-402B-86D6-441E916E13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2024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42</a:t>
            </a:r>
          </a:p>
        </p:txBody>
      </p:sp>
      <p:sp>
        <p:nvSpPr>
          <p:cNvPr id="61" name="Rectangle 58">
            <a:extLst>
              <a:ext uri="{FF2B5EF4-FFF2-40B4-BE49-F238E27FC236}">
                <a16:creationId xmlns:a16="http://schemas.microsoft.com/office/drawing/2014/main" id="{8F558211-2C47-4C1C-8989-F11323F60B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51436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8</a:t>
            </a:r>
          </a:p>
        </p:txBody>
      </p:sp>
      <p:sp>
        <p:nvSpPr>
          <p:cNvPr id="62" name="Rectangle 59">
            <a:extLst>
              <a:ext uri="{FF2B5EF4-FFF2-40B4-BE49-F238E27FC236}">
                <a16:creationId xmlns:a16="http://schemas.microsoft.com/office/drawing/2014/main" id="{A39E5588-08F4-4ACF-A7D5-B15354DC90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32436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6</a:t>
            </a:r>
          </a:p>
        </p:txBody>
      </p:sp>
      <p:sp>
        <p:nvSpPr>
          <p:cNvPr id="63" name="Rectangle 60">
            <a:extLst>
              <a:ext uri="{FF2B5EF4-FFF2-40B4-BE49-F238E27FC236}">
                <a16:creationId xmlns:a16="http://schemas.microsoft.com/office/drawing/2014/main" id="{5E2856ED-D3CD-42CD-A51A-3C23E32D44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52430" y="5196601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7</a:t>
            </a:r>
          </a:p>
        </p:txBody>
      </p:sp>
      <p:sp>
        <p:nvSpPr>
          <p:cNvPr id="64" name="Rectangle 61">
            <a:extLst>
              <a:ext uri="{FF2B5EF4-FFF2-40B4-BE49-F238E27FC236}">
                <a16:creationId xmlns:a16="http://schemas.microsoft.com/office/drawing/2014/main" id="{39F86042-F0CB-4B82-8D37-6FD4CAD355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31843" y="5196601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4</a:t>
            </a:r>
          </a:p>
        </p:txBody>
      </p:sp>
      <p:sp>
        <p:nvSpPr>
          <p:cNvPr id="65" name="Rectangle 62">
            <a:extLst>
              <a:ext uri="{FF2B5EF4-FFF2-40B4-BE49-F238E27FC236}">
                <a16:creationId xmlns:a16="http://schemas.microsoft.com/office/drawing/2014/main" id="{E9EF3AF8-8506-47A6-BFFD-4BAD1A44BB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12843" y="5196601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3</a:t>
            </a:r>
          </a:p>
        </p:txBody>
      </p:sp>
      <p:sp>
        <p:nvSpPr>
          <p:cNvPr id="66" name="Rectangle 63">
            <a:extLst>
              <a:ext uri="{FF2B5EF4-FFF2-40B4-BE49-F238E27FC236}">
                <a16:creationId xmlns:a16="http://schemas.microsoft.com/office/drawing/2014/main" id="{0B442883-FF18-41A1-89C0-D31456C1A1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90668" y="5196601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3</a:t>
            </a:r>
          </a:p>
        </p:txBody>
      </p:sp>
      <p:sp>
        <p:nvSpPr>
          <p:cNvPr id="67" name="Rectangle 64">
            <a:extLst>
              <a:ext uri="{FF2B5EF4-FFF2-40B4-BE49-F238E27FC236}">
                <a16:creationId xmlns:a16="http://schemas.microsoft.com/office/drawing/2014/main" id="{817A8EAD-9DBC-4FDC-AC50-2045028390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70080" y="5196601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0</a:t>
            </a:r>
          </a:p>
        </p:txBody>
      </p:sp>
      <p:sp>
        <p:nvSpPr>
          <p:cNvPr id="68" name="Rectangle 65">
            <a:extLst>
              <a:ext uri="{FF2B5EF4-FFF2-40B4-BE49-F238E27FC236}">
                <a16:creationId xmlns:a16="http://schemas.microsoft.com/office/drawing/2014/main" id="{CF8FDBA0-3BFC-47C5-B9A7-C213E818E6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30095" y="5196601"/>
            <a:ext cx="98745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dirty="0"/>
              <a:t>P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effectLst/>
              </a:rPr>
              <a:t>rior </a:t>
            </a:r>
            <a:r>
              <a:rPr lang="en-US" altLang="en-US" sz="1200" dirty="0"/>
              <a:t>LEN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effectLst/>
              </a:rPr>
              <a:t>+ PI</a:t>
            </a:r>
          </a:p>
        </p:txBody>
      </p:sp>
      <p:grpSp>
        <p:nvGrpSpPr>
          <p:cNvPr id="151" name="Group 150">
            <a:extLst>
              <a:ext uri="{FF2B5EF4-FFF2-40B4-BE49-F238E27FC236}">
                <a16:creationId xmlns:a16="http://schemas.microsoft.com/office/drawing/2014/main" id="{D70C64C9-5A43-4D44-B92C-DA481C52BC6F}"/>
              </a:ext>
            </a:extLst>
          </p:cNvPr>
          <p:cNvGrpSpPr/>
          <p:nvPr/>
        </p:nvGrpSpPr>
        <p:grpSpPr>
          <a:xfrm>
            <a:off x="3786188" y="1500505"/>
            <a:ext cx="5211762" cy="1292225"/>
            <a:chOff x="3786188" y="1584325"/>
            <a:chExt cx="5211762" cy="1292225"/>
          </a:xfrm>
        </p:grpSpPr>
        <p:sp>
          <p:nvSpPr>
            <p:cNvPr id="73" name="Freeform 70">
              <a:extLst>
                <a:ext uri="{FF2B5EF4-FFF2-40B4-BE49-F238E27FC236}">
                  <a16:creationId xmlns:a16="http://schemas.microsoft.com/office/drawing/2014/main" id="{CE1C1C3C-2FB2-43B8-A89B-7B73947A814F}"/>
                </a:ext>
              </a:extLst>
            </p:cNvPr>
            <p:cNvSpPr>
              <a:spLocks/>
            </p:cNvSpPr>
            <p:nvPr/>
          </p:nvSpPr>
          <p:spPr bwMode="auto">
            <a:xfrm>
              <a:off x="3802063" y="1609725"/>
              <a:ext cx="5170488" cy="1244600"/>
            </a:xfrm>
            <a:custGeom>
              <a:avLst/>
              <a:gdLst>
                <a:gd name="T0" fmla="*/ 4 w 3257"/>
                <a:gd name="T1" fmla="*/ 0 h 784"/>
                <a:gd name="T2" fmla="*/ 104 w 3257"/>
                <a:gd name="T3" fmla="*/ 18 h 784"/>
                <a:gd name="T4" fmla="*/ 120 w 3257"/>
                <a:gd name="T5" fmla="*/ 18 h 784"/>
                <a:gd name="T6" fmla="*/ 124 w 3257"/>
                <a:gd name="T7" fmla="*/ 42 h 784"/>
                <a:gd name="T8" fmla="*/ 224 w 3257"/>
                <a:gd name="T9" fmla="*/ 42 h 784"/>
                <a:gd name="T10" fmla="*/ 254 w 3257"/>
                <a:gd name="T11" fmla="*/ 60 h 784"/>
                <a:gd name="T12" fmla="*/ 274 w 3257"/>
                <a:gd name="T13" fmla="*/ 84 h 784"/>
                <a:gd name="T14" fmla="*/ 362 w 3257"/>
                <a:gd name="T15" fmla="*/ 84 h 784"/>
                <a:gd name="T16" fmla="*/ 392 w 3257"/>
                <a:gd name="T17" fmla="*/ 106 h 784"/>
                <a:gd name="T18" fmla="*/ 434 w 3257"/>
                <a:gd name="T19" fmla="*/ 130 h 784"/>
                <a:gd name="T20" fmla="*/ 438 w 3257"/>
                <a:gd name="T21" fmla="*/ 152 h 784"/>
                <a:gd name="T22" fmla="*/ 547 w 3257"/>
                <a:gd name="T23" fmla="*/ 152 h 784"/>
                <a:gd name="T24" fmla="*/ 581 w 3257"/>
                <a:gd name="T25" fmla="*/ 177 h 784"/>
                <a:gd name="T26" fmla="*/ 693 w 3257"/>
                <a:gd name="T27" fmla="*/ 177 h 784"/>
                <a:gd name="T28" fmla="*/ 801 w 3257"/>
                <a:gd name="T29" fmla="*/ 177 h 784"/>
                <a:gd name="T30" fmla="*/ 877 w 3257"/>
                <a:gd name="T31" fmla="*/ 203 h 784"/>
                <a:gd name="T32" fmla="*/ 907 w 3257"/>
                <a:gd name="T33" fmla="*/ 253 h 784"/>
                <a:gd name="T34" fmla="*/ 969 w 3257"/>
                <a:gd name="T35" fmla="*/ 277 h 784"/>
                <a:gd name="T36" fmla="*/ 993 w 3257"/>
                <a:gd name="T37" fmla="*/ 299 h 784"/>
                <a:gd name="T38" fmla="*/ 1107 w 3257"/>
                <a:gd name="T39" fmla="*/ 327 h 784"/>
                <a:gd name="T40" fmla="*/ 1127 w 3257"/>
                <a:gd name="T41" fmla="*/ 349 h 784"/>
                <a:gd name="T42" fmla="*/ 1162 w 3257"/>
                <a:gd name="T43" fmla="*/ 377 h 784"/>
                <a:gd name="T44" fmla="*/ 1250 w 3257"/>
                <a:gd name="T45" fmla="*/ 377 h 784"/>
                <a:gd name="T46" fmla="*/ 1296 w 3257"/>
                <a:gd name="T47" fmla="*/ 403 h 784"/>
                <a:gd name="T48" fmla="*/ 1320 w 3257"/>
                <a:gd name="T49" fmla="*/ 427 h 784"/>
                <a:gd name="T50" fmla="*/ 1346 w 3257"/>
                <a:gd name="T51" fmla="*/ 453 h 784"/>
                <a:gd name="T52" fmla="*/ 1484 w 3257"/>
                <a:gd name="T53" fmla="*/ 453 h 784"/>
                <a:gd name="T54" fmla="*/ 1534 w 3257"/>
                <a:gd name="T55" fmla="*/ 481 h 784"/>
                <a:gd name="T56" fmla="*/ 1538 w 3257"/>
                <a:gd name="T57" fmla="*/ 507 h 784"/>
                <a:gd name="T58" fmla="*/ 1580 w 3257"/>
                <a:gd name="T59" fmla="*/ 507 h 784"/>
                <a:gd name="T60" fmla="*/ 1622 w 3257"/>
                <a:gd name="T61" fmla="*/ 533 h 784"/>
                <a:gd name="T62" fmla="*/ 1634 w 3257"/>
                <a:gd name="T63" fmla="*/ 566 h 784"/>
                <a:gd name="T64" fmla="*/ 1650 w 3257"/>
                <a:gd name="T65" fmla="*/ 566 h 784"/>
                <a:gd name="T66" fmla="*/ 1696 w 3257"/>
                <a:gd name="T67" fmla="*/ 566 h 784"/>
                <a:gd name="T68" fmla="*/ 1768 w 3257"/>
                <a:gd name="T69" fmla="*/ 566 h 784"/>
                <a:gd name="T70" fmla="*/ 1792 w 3257"/>
                <a:gd name="T71" fmla="*/ 566 h 784"/>
                <a:gd name="T72" fmla="*/ 1873 w 3257"/>
                <a:gd name="T73" fmla="*/ 566 h 784"/>
                <a:gd name="T74" fmla="*/ 1889 w 3257"/>
                <a:gd name="T75" fmla="*/ 566 h 784"/>
                <a:gd name="T76" fmla="*/ 1901 w 3257"/>
                <a:gd name="T77" fmla="*/ 608 h 784"/>
                <a:gd name="T78" fmla="*/ 1927 w 3257"/>
                <a:gd name="T79" fmla="*/ 608 h 784"/>
                <a:gd name="T80" fmla="*/ 1957 w 3257"/>
                <a:gd name="T81" fmla="*/ 608 h 784"/>
                <a:gd name="T82" fmla="*/ 1981 w 3257"/>
                <a:gd name="T83" fmla="*/ 608 h 784"/>
                <a:gd name="T84" fmla="*/ 2005 w 3257"/>
                <a:gd name="T85" fmla="*/ 608 h 784"/>
                <a:gd name="T86" fmla="*/ 2103 w 3257"/>
                <a:gd name="T87" fmla="*/ 608 h 784"/>
                <a:gd name="T88" fmla="*/ 2181 w 3257"/>
                <a:gd name="T89" fmla="*/ 608 h 784"/>
                <a:gd name="T90" fmla="*/ 2235 w 3257"/>
                <a:gd name="T91" fmla="*/ 608 h 784"/>
                <a:gd name="T92" fmla="*/ 2315 w 3257"/>
                <a:gd name="T93" fmla="*/ 696 h 784"/>
                <a:gd name="T94" fmla="*/ 2319 w 3257"/>
                <a:gd name="T95" fmla="*/ 784 h 784"/>
                <a:gd name="T96" fmla="*/ 2341 w 3257"/>
                <a:gd name="T97" fmla="*/ 784 h 784"/>
                <a:gd name="T98" fmla="*/ 2419 w 3257"/>
                <a:gd name="T99" fmla="*/ 784 h 784"/>
                <a:gd name="T100" fmla="*/ 2566 w 3257"/>
                <a:gd name="T101" fmla="*/ 784 h 784"/>
                <a:gd name="T102" fmla="*/ 3134 w 3257"/>
                <a:gd name="T103" fmla="*/ 784 h 784"/>
                <a:gd name="T104" fmla="*/ 3257 w 3257"/>
                <a:gd name="T105" fmla="*/ 784 h 7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</a:cxnLst>
              <a:rect l="0" t="0" r="r" b="b"/>
              <a:pathLst>
                <a:path w="3257" h="784">
                  <a:moveTo>
                    <a:pt x="0" y="0"/>
                  </a:moveTo>
                  <a:lnTo>
                    <a:pt x="4" y="0"/>
                  </a:lnTo>
                  <a:lnTo>
                    <a:pt x="104" y="0"/>
                  </a:lnTo>
                  <a:lnTo>
                    <a:pt x="104" y="18"/>
                  </a:lnTo>
                  <a:lnTo>
                    <a:pt x="112" y="18"/>
                  </a:lnTo>
                  <a:lnTo>
                    <a:pt x="120" y="18"/>
                  </a:lnTo>
                  <a:lnTo>
                    <a:pt x="120" y="42"/>
                  </a:lnTo>
                  <a:lnTo>
                    <a:pt x="124" y="42"/>
                  </a:lnTo>
                  <a:lnTo>
                    <a:pt x="220" y="42"/>
                  </a:lnTo>
                  <a:lnTo>
                    <a:pt x="224" y="42"/>
                  </a:lnTo>
                  <a:lnTo>
                    <a:pt x="254" y="42"/>
                  </a:lnTo>
                  <a:lnTo>
                    <a:pt x="254" y="60"/>
                  </a:lnTo>
                  <a:lnTo>
                    <a:pt x="274" y="60"/>
                  </a:lnTo>
                  <a:lnTo>
                    <a:pt x="274" y="84"/>
                  </a:lnTo>
                  <a:lnTo>
                    <a:pt x="334" y="84"/>
                  </a:lnTo>
                  <a:lnTo>
                    <a:pt x="362" y="84"/>
                  </a:lnTo>
                  <a:lnTo>
                    <a:pt x="362" y="106"/>
                  </a:lnTo>
                  <a:lnTo>
                    <a:pt x="392" y="106"/>
                  </a:lnTo>
                  <a:lnTo>
                    <a:pt x="434" y="106"/>
                  </a:lnTo>
                  <a:lnTo>
                    <a:pt x="434" y="130"/>
                  </a:lnTo>
                  <a:lnTo>
                    <a:pt x="438" y="130"/>
                  </a:lnTo>
                  <a:lnTo>
                    <a:pt x="438" y="152"/>
                  </a:lnTo>
                  <a:lnTo>
                    <a:pt x="458" y="152"/>
                  </a:lnTo>
                  <a:lnTo>
                    <a:pt x="547" y="152"/>
                  </a:lnTo>
                  <a:lnTo>
                    <a:pt x="547" y="177"/>
                  </a:lnTo>
                  <a:lnTo>
                    <a:pt x="581" y="177"/>
                  </a:lnTo>
                  <a:lnTo>
                    <a:pt x="661" y="177"/>
                  </a:lnTo>
                  <a:lnTo>
                    <a:pt x="693" y="177"/>
                  </a:lnTo>
                  <a:lnTo>
                    <a:pt x="777" y="177"/>
                  </a:lnTo>
                  <a:lnTo>
                    <a:pt x="801" y="177"/>
                  </a:lnTo>
                  <a:lnTo>
                    <a:pt x="801" y="203"/>
                  </a:lnTo>
                  <a:lnTo>
                    <a:pt x="877" y="203"/>
                  </a:lnTo>
                  <a:lnTo>
                    <a:pt x="907" y="203"/>
                  </a:lnTo>
                  <a:lnTo>
                    <a:pt x="907" y="253"/>
                  </a:lnTo>
                  <a:lnTo>
                    <a:pt x="969" y="253"/>
                  </a:lnTo>
                  <a:lnTo>
                    <a:pt x="969" y="277"/>
                  </a:lnTo>
                  <a:lnTo>
                    <a:pt x="993" y="277"/>
                  </a:lnTo>
                  <a:lnTo>
                    <a:pt x="993" y="299"/>
                  </a:lnTo>
                  <a:lnTo>
                    <a:pt x="1107" y="299"/>
                  </a:lnTo>
                  <a:lnTo>
                    <a:pt x="1107" y="327"/>
                  </a:lnTo>
                  <a:lnTo>
                    <a:pt x="1127" y="327"/>
                  </a:lnTo>
                  <a:lnTo>
                    <a:pt x="1127" y="349"/>
                  </a:lnTo>
                  <a:lnTo>
                    <a:pt x="1162" y="349"/>
                  </a:lnTo>
                  <a:lnTo>
                    <a:pt x="1162" y="377"/>
                  </a:lnTo>
                  <a:lnTo>
                    <a:pt x="1242" y="377"/>
                  </a:lnTo>
                  <a:lnTo>
                    <a:pt x="1250" y="377"/>
                  </a:lnTo>
                  <a:lnTo>
                    <a:pt x="1250" y="403"/>
                  </a:lnTo>
                  <a:lnTo>
                    <a:pt x="1296" y="403"/>
                  </a:lnTo>
                  <a:lnTo>
                    <a:pt x="1296" y="427"/>
                  </a:lnTo>
                  <a:lnTo>
                    <a:pt x="1320" y="427"/>
                  </a:lnTo>
                  <a:lnTo>
                    <a:pt x="1346" y="427"/>
                  </a:lnTo>
                  <a:lnTo>
                    <a:pt x="1346" y="453"/>
                  </a:lnTo>
                  <a:lnTo>
                    <a:pt x="1374" y="453"/>
                  </a:lnTo>
                  <a:lnTo>
                    <a:pt x="1484" y="453"/>
                  </a:lnTo>
                  <a:lnTo>
                    <a:pt x="1534" y="453"/>
                  </a:lnTo>
                  <a:lnTo>
                    <a:pt x="1534" y="481"/>
                  </a:lnTo>
                  <a:lnTo>
                    <a:pt x="1538" y="481"/>
                  </a:lnTo>
                  <a:lnTo>
                    <a:pt x="1538" y="507"/>
                  </a:lnTo>
                  <a:lnTo>
                    <a:pt x="1566" y="507"/>
                  </a:lnTo>
                  <a:lnTo>
                    <a:pt x="1580" y="507"/>
                  </a:lnTo>
                  <a:lnTo>
                    <a:pt x="1622" y="507"/>
                  </a:lnTo>
                  <a:lnTo>
                    <a:pt x="1622" y="533"/>
                  </a:lnTo>
                  <a:lnTo>
                    <a:pt x="1634" y="533"/>
                  </a:lnTo>
                  <a:lnTo>
                    <a:pt x="1634" y="566"/>
                  </a:lnTo>
                  <a:lnTo>
                    <a:pt x="1646" y="566"/>
                  </a:lnTo>
                  <a:lnTo>
                    <a:pt x="1650" y="566"/>
                  </a:lnTo>
                  <a:lnTo>
                    <a:pt x="1672" y="566"/>
                  </a:lnTo>
                  <a:lnTo>
                    <a:pt x="1696" y="566"/>
                  </a:lnTo>
                  <a:lnTo>
                    <a:pt x="1762" y="566"/>
                  </a:lnTo>
                  <a:lnTo>
                    <a:pt x="1768" y="566"/>
                  </a:lnTo>
                  <a:lnTo>
                    <a:pt x="1776" y="566"/>
                  </a:lnTo>
                  <a:lnTo>
                    <a:pt x="1792" y="566"/>
                  </a:lnTo>
                  <a:lnTo>
                    <a:pt x="1869" y="566"/>
                  </a:lnTo>
                  <a:lnTo>
                    <a:pt x="1873" y="566"/>
                  </a:lnTo>
                  <a:lnTo>
                    <a:pt x="1881" y="566"/>
                  </a:lnTo>
                  <a:lnTo>
                    <a:pt x="1889" y="566"/>
                  </a:lnTo>
                  <a:lnTo>
                    <a:pt x="1901" y="566"/>
                  </a:lnTo>
                  <a:lnTo>
                    <a:pt x="1901" y="608"/>
                  </a:lnTo>
                  <a:lnTo>
                    <a:pt x="1923" y="608"/>
                  </a:lnTo>
                  <a:lnTo>
                    <a:pt x="1927" y="608"/>
                  </a:lnTo>
                  <a:lnTo>
                    <a:pt x="1931" y="608"/>
                  </a:lnTo>
                  <a:lnTo>
                    <a:pt x="1957" y="608"/>
                  </a:lnTo>
                  <a:lnTo>
                    <a:pt x="1965" y="608"/>
                  </a:lnTo>
                  <a:lnTo>
                    <a:pt x="1981" y="608"/>
                  </a:lnTo>
                  <a:lnTo>
                    <a:pt x="1985" y="608"/>
                  </a:lnTo>
                  <a:lnTo>
                    <a:pt x="2005" y="608"/>
                  </a:lnTo>
                  <a:lnTo>
                    <a:pt x="2085" y="608"/>
                  </a:lnTo>
                  <a:lnTo>
                    <a:pt x="2103" y="608"/>
                  </a:lnTo>
                  <a:lnTo>
                    <a:pt x="2147" y="608"/>
                  </a:lnTo>
                  <a:lnTo>
                    <a:pt x="2181" y="608"/>
                  </a:lnTo>
                  <a:lnTo>
                    <a:pt x="2199" y="608"/>
                  </a:lnTo>
                  <a:lnTo>
                    <a:pt x="2235" y="608"/>
                  </a:lnTo>
                  <a:lnTo>
                    <a:pt x="2235" y="696"/>
                  </a:lnTo>
                  <a:lnTo>
                    <a:pt x="2315" y="696"/>
                  </a:lnTo>
                  <a:lnTo>
                    <a:pt x="2315" y="784"/>
                  </a:lnTo>
                  <a:lnTo>
                    <a:pt x="2319" y="784"/>
                  </a:lnTo>
                  <a:lnTo>
                    <a:pt x="2339" y="784"/>
                  </a:lnTo>
                  <a:lnTo>
                    <a:pt x="2341" y="784"/>
                  </a:lnTo>
                  <a:lnTo>
                    <a:pt x="2365" y="784"/>
                  </a:lnTo>
                  <a:lnTo>
                    <a:pt x="2419" y="784"/>
                  </a:lnTo>
                  <a:lnTo>
                    <a:pt x="2445" y="784"/>
                  </a:lnTo>
                  <a:lnTo>
                    <a:pt x="2566" y="784"/>
                  </a:lnTo>
                  <a:lnTo>
                    <a:pt x="2724" y="784"/>
                  </a:lnTo>
                  <a:lnTo>
                    <a:pt x="3134" y="784"/>
                  </a:lnTo>
                  <a:lnTo>
                    <a:pt x="3146" y="784"/>
                  </a:lnTo>
                  <a:lnTo>
                    <a:pt x="3257" y="784"/>
                  </a:lnTo>
                </a:path>
              </a:pathLst>
            </a:cu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150" name="Group 149">
              <a:extLst>
                <a:ext uri="{FF2B5EF4-FFF2-40B4-BE49-F238E27FC236}">
                  <a16:creationId xmlns:a16="http://schemas.microsoft.com/office/drawing/2014/main" id="{B7CAC6E4-D9A8-4783-B263-16370D0021B2}"/>
                </a:ext>
              </a:extLst>
            </p:cNvPr>
            <p:cNvGrpSpPr/>
            <p:nvPr/>
          </p:nvGrpSpPr>
          <p:grpSpPr>
            <a:xfrm>
              <a:off x="3786188" y="1584325"/>
              <a:ext cx="5211762" cy="1292225"/>
              <a:chOff x="3786188" y="1584325"/>
              <a:chExt cx="5211762" cy="1292225"/>
            </a:xfrm>
          </p:grpSpPr>
          <p:sp>
            <p:nvSpPr>
              <p:cNvPr id="74" name="Line 71">
                <a:extLst>
                  <a:ext uri="{FF2B5EF4-FFF2-40B4-BE49-F238E27FC236}">
                    <a16:creationId xmlns:a16="http://schemas.microsoft.com/office/drawing/2014/main" id="{8F14A185-93F0-4BEF-95CE-F4F469713F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86188" y="1609725"/>
                <a:ext cx="44450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5" name="Line 72">
                <a:extLst>
                  <a:ext uri="{FF2B5EF4-FFF2-40B4-BE49-F238E27FC236}">
                    <a16:creationId xmlns:a16="http://schemas.microsoft.com/office/drawing/2014/main" id="{998C181B-5374-4F92-A355-A70B2CA311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08413" y="1584325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6" name="Line 73">
                <a:extLst>
                  <a:ext uri="{FF2B5EF4-FFF2-40B4-BE49-F238E27FC236}">
                    <a16:creationId xmlns:a16="http://schemas.microsoft.com/office/drawing/2014/main" id="{DF136110-B4F7-44C6-A2E7-5B7192BBF0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67163" y="1638300"/>
                <a:ext cx="25400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7" name="Line 74">
                <a:extLst>
                  <a:ext uri="{FF2B5EF4-FFF2-40B4-BE49-F238E27FC236}">
                    <a16:creationId xmlns:a16="http://schemas.microsoft.com/office/drawing/2014/main" id="{6192493D-795B-4A3A-9B0C-D7114324E1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79863" y="1625600"/>
                <a:ext cx="0" cy="2540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8" name="Line 75">
                <a:extLst>
                  <a:ext uri="{FF2B5EF4-FFF2-40B4-BE49-F238E27FC236}">
                    <a16:creationId xmlns:a16="http://schemas.microsoft.com/office/drawing/2014/main" id="{15FD546F-8C5D-44D8-B1ED-522EEFE4C2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57638" y="1638300"/>
                <a:ext cx="44450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9" name="Line 76">
                <a:extLst>
                  <a:ext uri="{FF2B5EF4-FFF2-40B4-BE49-F238E27FC236}">
                    <a16:creationId xmlns:a16="http://schemas.microsoft.com/office/drawing/2014/main" id="{5725310B-181A-4D36-8BBD-97D9D3F814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79863" y="161607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0" name="Line 77">
                <a:extLst>
                  <a:ext uri="{FF2B5EF4-FFF2-40B4-BE49-F238E27FC236}">
                    <a16:creationId xmlns:a16="http://schemas.microsoft.com/office/drawing/2014/main" id="{34DA191A-54F3-41DE-A33C-34A56CD696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73513" y="1676400"/>
                <a:ext cx="47625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1" name="Line 78">
                <a:extLst>
                  <a:ext uri="{FF2B5EF4-FFF2-40B4-BE49-F238E27FC236}">
                    <a16:creationId xmlns:a16="http://schemas.microsoft.com/office/drawing/2014/main" id="{43E25AFF-5061-49DD-B537-A8E167E749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98913" y="1651000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2" name="Line 79">
                <a:extLst>
                  <a:ext uri="{FF2B5EF4-FFF2-40B4-BE49-F238E27FC236}">
                    <a16:creationId xmlns:a16="http://schemas.microsoft.com/office/drawing/2014/main" id="{91CF6038-0F04-499D-8407-D21FA2DB8E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51313" y="1651000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3" name="Line 80">
                <a:extLst>
                  <a:ext uri="{FF2B5EF4-FFF2-40B4-BE49-F238E27FC236}">
                    <a16:creationId xmlns:a16="http://schemas.microsoft.com/office/drawing/2014/main" id="{6592FC9F-307A-44E7-8F62-149BBBDDC3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57663" y="1651000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4" name="Line 81">
                <a:extLst>
                  <a:ext uri="{FF2B5EF4-FFF2-40B4-BE49-F238E27FC236}">
                    <a16:creationId xmlns:a16="http://schemas.microsoft.com/office/drawing/2014/main" id="{625358B4-64C6-4999-AB7C-82627F47BC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32288" y="172085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5" name="Line 82">
                <a:extLst>
                  <a:ext uri="{FF2B5EF4-FFF2-40B4-BE49-F238E27FC236}">
                    <a16:creationId xmlns:a16="http://schemas.microsoft.com/office/drawing/2014/main" id="{D686EBC3-E4C7-4365-86CD-713B0F139A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24363" y="175577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6" name="Line 83">
                <a:extLst>
                  <a:ext uri="{FF2B5EF4-FFF2-40B4-BE49-F238E27FC236}">
                    <a16:creationId xmlns:a16="http://schemas.microsoft.com/office/drawing/2014/main" id="{5ED4CC04-4A04-493A-A1AA-005919A548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29138" y="1828800"/>
                <a:ext cx="0" cy="49213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7" name="Line 84">
                <a:extLst>
                  <a:ext uri="{FF2B5EF4-FFF2-40B4-BE49-F238E27FC236}">
                    <a16:creationId xmlns:a16="http://schemas.microsoft.com/office/drawing/2014/main" id="{5046BDEB-E9B0-4B0E-A16C-9CCC183AFB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24400" y="186848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8" name="Line 85">
                <a:extLst>
                  <a:ext uri="{FF2B5EF4-FFF2-40B4-BE49-F238E27FC236}">
                    <a16:creationId xmlns:a16="http://schemas.microsoft.com/office/drawing/2014/main" id="{CF0FF836-B1CC-4248-8910-A357CC9C1A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51400" y="186848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9" name="Line 86">
                <a:extLst>
                  <a:ext uri="{FF2B5EF4-FFF2-40B4-BE49-F238E27FC236}">
                    <a16:creationId xmlns:a16="http://schemas.microsoft.com/office/drawing/2014/main" id="{B40824C2-6F92-419B-80B5-E03A8B63FE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02200" y="186848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0" name="Line 87">
                <a:extLst>
                  <a:ext uri="{FF2B5EF4-FFF2-40B4-BE49-F238E27FC236}">
                    <a16:creationId xmlns:a16="http://schemas.microsoft.com/office/drawing/2014/main" id="{834538A8-2921-49D0-AFD2-7603D2F0DF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35550" y="186848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1" name="Line 88">
                <a:extLst>
                  <a:ext uri="{FF2B5EF4-FFF2-40B4-BE49-F238E27FC236}">
                    <a16:creationId xmlns:a16="http://schemas.microsoft.com/office/drawing/2014/main" id="{222967BB-62BB-46ED-AF8B-A105571A91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94300" y="1909763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2" name="Line 89">
                <a:extLst>
                  <a:ext uri="{FF2B5EF4-FFF2-40B4-BE49-F238E27FC236}">
                    <a16:creationId xmlns:a16="http://schemas.microsoft.com/office/drawing/2014/main" id="{F073D88B-CFBD-4578-8CD6-92BE6A96DA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51513" y="2208213"/>
                <a:ext cx="47625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3" name="Line 90">
                <a:extLst>
                  <a:ext uri="{FF2B5EF4-FFF2-40B4-BE49-F238E27FC236}">
                    <a16:creationId xmlns:a16="http://schemas.microsoft.com/office/drawing/2014/main" id="{FE0F7CB2-925E-4111-B086-145B8F4EAC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73738" y="2182813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4" name="Line 91">
                <a:extLst>
                  <a:ext uri="{FF2B5EF4-FFF2-40B4-BE49-F238E27FC236}">
                    <a16:creationId xmlns:a16="http://schemas.microsoft.com/office/drawing/2014/main" id="{BCF8A795-BFEA-4F88-A33A-A23BD45718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97563" y="22621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5" name="Line 92">
                <a:extLst>
                  <a:ext uri="{FF2B5EF4-FFF2-40B4-BE49-F238E27FC236}">
                    <a16:creationId xmlns:a16="http://schemas.microsoft.com/office/drawing/2014/main" id="{E2F7C454-560A-437D-B82F-7EA9D01C5A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983288" y="23066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6" name="Line 93">
                <a:extLst>
                  <a:ext uri="{FF2B5EF4-FFF2-40B4-BE49-F238E27FC236}">
                    <a16:creationId xmlns:a16="http://schemas.microsoft.com/office/drawing/2014/main" id="{6BE7E632-49B4-4A7D-9B03-7EE59B81C0A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157913" y="23066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7" name="Line 94">
                <a:extLst>
                  <a:ext uri="{FF2B5EF4-FFF2-40B4-BE49-F238E27FC236}">
                    <a16:creationId xmlns:a16="http://schemas.microsoft.com/office/drawing/2014/main" id="{E4BF8E6E-3FF1-46C7-8D28-055B5E207A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88088" y="2392363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8" name="Line 95">
                <a:extLst>
                  <a:ext uri="{FF2B5EF4-FFF2-40B4-BE49-F238E27FC236}">
                    <a16:creationId xmlns:a16="http://schemas.microsoft.com/office/drawing/2014/main" id="{8CB6F0E7-D98C-4FD4-B8B9-2FBDA8F11E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310313" y="2392363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9" name="Line 96">
                <a:extLst>
                  <a:ext uri="{FF2B5EF4-FFF2-40B4-BE49-F238E27FC236}">
                    <a16:creationId xmlns:a16="http://schemas.microsoft.com/office/drawing/2014/main" id="{B3889FD3-B63D-4ACD-BF3B-EC132D3691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354763" y="2455863"/>
                <a:ext cx="47625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0" name="Line 97">
                <a:extLst>
                  <a:ext uri="{FF2B5EF4-FFF2-40B4-BE49-F238E27FC236}">
                    <a16:creationId xmlns:a16="http://schemas.microsoft.com/office/drawing/2014/main" id="{EEBCBF06-AF27-4C07-B123-BC5494BD36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376988" y="2433638"/>
                <a:ext cx="0" cy="49213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1" name="Line 98">
                <a:extLst>
                  <a:ext uri="{FF2B5EF4-FFF2-40B4-BE49-F238E27FC236}">
                    <a16:creationId xmlns:a16="http://schemas.microsoft.com/office/drawing/2014/main" id="{8D041B45-1A3B-40F7-A92E-5732335DA8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392863" y="2508250"/>
                <a:ext cx="44450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2" name="Line 99">
                <a:extLst>
                  <a:ext uri="{FF2B5EF4-FFF2-40B4-BE49-F238E27FC236}">
                    <a16:creationId xmlns:a16="http://schemas.microsoft.com/office/drawing/2014/main" id="{6B41F756-E39F-4747-8DD2-5CAE8F3CB8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15088" y="248602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3" name="Line 100">
                <a:extLst>
                  <a:ext uri="{FF2B5EF4-FFF2-40B4-BE49-F238E27FC236}">
                    <a16:creationId xmlns:a16="http://schemas.microsoft.com/office/drawing/2014/main" id="{C7BBA7B4-AAAA-45E0-AB0D-B92F4F5A6A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21438" y="248602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4" name="Line 101">
                <a:extLst>
                  <a:ext uri="{FF2B5EF4-FFF2-40B4-BE49-F238E27FC236}">
                    <a16:creationId xmlns:a16="http://schemas.microsoft.com/office/drawing/2014/main" id="{062B4577-F6EB-411D-88D9-4BA5DE84F4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21438" y="248602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5" name="Line 102">
                <a:extLst>
                  <a:ext uri="{FF2B5EF4-FFF2-40B4-BE49-F238E27FC236}">
                    <a16:creationId xmlns:a16="http://schemas.microsoft.com/office/drawing/2014/main" id="{712DD28F-3AB8-4723-8186-08AE95764E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56363" y="248602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6" name="Line 103">
                <a:extLst>
                  <a:ext uri="{FF2B5EF4-FFF2-40B4-BE49-F238E27FC236}">
                    <a16:creationId xmlns:a16="http://schemas.microsoft.com/office/drawing/2014/main" id="{6AD5623C-0E34-4E0F-967D-0B4FA62AD9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56363" y="248602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7" name="Line 104">
                <a:extLst>
                  <a:ext uri="{FF2B5EF4-FFF2-40B4-BE49-F238E27FC236}">
                    <a16:creationId xmlns:a16="http://schemas.microsoft.com/office/drawing/2014/main" id="{9260BEF7-321E-4F2A-9A49-4C4CB9E564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94463" y="248602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" name="Line 105">
                <a:extLst>
                  <a:ext uri="{FF2B5EF4-FFF2-40B4-BE49-F238E27FC236}">
                    <a16:creationId xmlns:a16="http://schemas.microsoft.com/office/drawing/2014/main" id="{D48A3F1F-5390-471F-B46D-D81D4391E6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599238" y="248602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" name="Line 106">
                <a:extLst>
                  <a:ext uri="{FF2B5EF4-FFF2-40B4-BE49-F238E27FC236}">
                    <a16:creationId xmlns:a16="http://schemas.microsoft.com/office/drawing/2014/main" id="{48C1642E-7C39-4B36-AE05-8B248B1E3E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08763" y="248602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" name="Line 107">
                <a:extLst>
                  <a:ext uri="{FF2B5EF4-FFF2-40B4-BE49-F238E27FC236}">
                    <a16:creationId xmlns:a16="http://schemas.microsoft.com/office/drawing/2014/main" id="{D6075CA2-0077-4C6A-A763-F8AA8A5391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21463" y="248602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" name="Line 108">
                <a:extLst>
                  <a:ext uri="{FF2B5EF4-FFF2-40B4-BE49-F238E27FC236}">
                    <a16:creationId xmlns:a16="http://schemas.microsoft.com/office/drawing/2014/main" id="{F8DA9F9B-DB58-4477-9FD9-50A7B1A4C4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46863" y="248602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" name="Line 109">
                <a:extLst>
                  <a:ext uri="{FF2B5EF4-FFF2-40B4-BE49-F238E27FC236}">
                    <a16:creationId xmlns:a16="http://schemas.microsoft.com/office/drawing/2014/main" id="{96851B6D-E913-4B01-8D4E-50B6EA2194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69100" y="248602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" name="Line 110">
                <a:extLst>
                  <a:ext uri="{FF2B5EF4-FFF2-40B4-BE49-F238E27FC236}">
                    <a16:creationId xmlns:a16="http://schemas.microsoft.com/office/drawing/2014/main" id="{AD8AB5A2-258C-4D59-8B47-E4E0C5CA36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75450" y="248602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" name="Line 111">
                <a:extLst>
                  <a:ext uri="{FF2B5EF4-FFF2-40B4-BE49-F238E27FC236}">
                    <a16:creationId xmlns:a16="http://schemas.microsoft.com/office/drawing/2014/main" id="{8917332C-F385-44D9-8C80-10CE236971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75450" y="248602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" name="Line 112">
                <a:extLst>
                  <a:ext uri="{FF2B5EF4-FFF2-40B4-BE49-F238E27FC236}">
                    <a16:creationId xmlns:a16="http://schemas.microsoft.com/office/drawing/2014/main" id="{15068B6F-60EF-47B3-BF1F-C2685D46EB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88150" y="248602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" name="Line 113">
                <a:extLst>
                  <a:ext uri="{FF2B5EF4-FFF2-40B4-BE49-F238E27FC236}">
                    <a16:creationId xmlns:a16="http://schemas.microsoft.com/office/drawing/2014/main" id="{20DD9351-1CFE-4C17-8074-CD8A6C45FF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778625" y="2508250"/>
                <a:ext cx="44450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" name="Line 114">
                <a:extLst>
                  <a:ext uri="{FF2B5EF4-FFF2-40B4-BE49-F238E27FC236}">
                    <a16:creationId xmlns:a16="http://schemas.microsoft.com/office/drawing/2014/main" id="{7A541A3D-EBCB-493B-9569-C7006919F9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00850" y="248602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" name="Line 115">
                <a:extLst>
                  <a:ext uri="{FF2B5EF4-FFF2-40B4-BE49-F238E27FC236}">
                    <a16:creationId xmlns:a16="http://schemas.microsoft.com/office/drawing/2014/main" id="{075408A9-33EE-4DFB-A026-295ACA484D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794500" y="2574925"/>
                <a:ext cx="47625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" name="Line 116">
                <a:extLst>
                  <a:ext uri="{FF2B5EF4-FFF2-40B4-BE49-F238E27FC236}">
                    <a16:creationId xmlns:a16="http://schemas.microsoft.com/office/drawing/2014/main" id="{547DAF90-536B-4BC5-A235-50AE4100FE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19900" y="25527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" name="Line 117">
                <a:extLst>
                  <a:ext uri="{FF2B5EF4-FFF2-40B4-BE49-F238E27FC236}">
                    <a16:creationId xmlns:a16="http://schemas.microsoft.com/office/drawing/2014/main" id="{548A4A54-CD8A-424C-B049-DDAD415394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54825" y="25527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" name="Line 118">
                <a:extLst>
                  <a:ext uri="{FF2B5EF4-FFF2-40B4-BE49-F238E27FC236}">
                    <a16:creationId xmlns:a16="http://schemas.microsoft.com/office/drawing/2014/main" id="{D8278F99-84EE-4474-A544-EB9A754087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61175" y="25527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" name="Line 119">
                <a:extLst>
                  <a:ext uri="{FF2B5EF4-FFF2-40B4-BE49-F238E27FC236}">
                    <a16:creationId xmlns:a16="http://schemas.microsoft.com/office/drawing/2014/main" id="{0CA13C4C-FD2E-40C5-9A6E-E47009EBA0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67525" y="25527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" name="Line 120">
                <a:extLst>
                  <a:ext uri="{FF2B5EF4-FFF2-40B4-BE49-F238E27FC236}">
                    <a16:creationId xmlns:a16="http://schemas.microsoft.com/office/drawing/2014/main" id="{17608FFE-EB12-4C4B-ABDF-8AC3B9E6B0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08800" y="25527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" name="Line 121">
                <a:extLst>
                  <a:ext uri="{FF2B5EF4-FFF2-40B4-BE49-F238E27FC236}">
                    <a16:creationId xmlns:a16="http://schemas.microsoft.com/office/drawing/2014/main" id="{73704451-E827-464F-A271-48CD1B4D1B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08800" y="25527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5" name="Line 122">
                <a:extLst>
                  <a:ext uri="{FF2B5EF4-FFF2-40B4-BE49-F238E27FC236}">
                    <a16:creationId xmlns:a16="http://schemas.microsoft.com/office/drawing/2014/main" id="{2EF9DA21-E567-4157-9BC8-4D684FB159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21500" y="25527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6" name="Line 123">
                <a:extLst>
                  <a:ext uri="{FF2B5EF4-FFF2-40B4-BE49-F238E27FC236}">
                    <a16:creationId xmlns:a16="http://schemas.microsoft.com/office/drawing/2014/main" id="{BCDB37EA-470F-471C-BCC9-193C9D5143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46900" y="25527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7" name="Line 124">
                <a:extLst>
                  <a:ext uri="{FF2B5EF4-FFF2-40B4-BE49-F238E27FC236}">
                    <a16:creationId xmlns:a16="http://schemas.microsoft.com/office/drawing/2014/main" id="{AA9AB19E-7EA2-4DDA-B2CB-FB72492807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53250" y="25527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8" name="Line 125">
                <a:extLst>
                  <a:ext uri="{FF2B5EF4-FFF2-40B4-BE49-F238E27FC236}">
                    <a16:creationId xmlns:a16="http://schemas.microsoft.com/office/drawing/2014/main" id="{FCEDB20D-AF31-4E4D-BAE7-F8C894465C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85000" y="25527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9" name="Line 126">
                <a:extLst>
                  <a:ext uri="{FF2B5EF4-FFF2-40B4-BE49-F238E27FC236}">
                    <a16:creationId xmlns:a16="http://schemas.microsoft.com/office/drawing/2014/main" id="{72C9F049-1CF7-41BF-86BA-332624AF96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12000" y="25527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" name="Line 127">
                <a:extLst>
                  <a:ext uri="{FF2B5EF4-FFF2-40B4-BE49-F238E27FC236}">
                    <a16:creationId xmlns:a16="http://schemas.microsoft.com/office/drawing/2014/main" id="{D24BB6ED-E0C8-46BF-92AA-919D04BC97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40575" y="25527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" name="Line 128">
                <a:extLst>
                  <a:ext uri="{FF2B5EF4-FFF2-40B4-BE49-F238E27FC236}">
                    <a16:creationId xmlns:a16="http://schemas.microsoft.com/office/drawing/2014/main" id="{DCBD357B-C402-4C40-B086-6E4A2D7F5E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10425" y="25527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" name="Line 129">
                <a:extLst>
                  <a:ext uri="{FF2B5EF4-FFF2-40B4-BE49-F238E27FC236}">
                    <a16:creationId xmlns:a16="http://schemas.microsoft.com/office/drawing/2014/main" id="{6F7C3FEE-5647-4098-9993-D4DBA0CC2C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64400" y="25527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" name="Line 130">
                <a:extLst>
                  <a:ext uri="{FF2B5EF4-FFF2-40B4-BE49-F238E27FC236}">
                    <a16:creationId xmlns:a16="http://schemas.microsoft.com/office/drawing/2014/main" id="{1D690744-22F0-4980-8CB0-0E75318210B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92975" y="25527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" name="Line 131">
                <a:extLst>
                  <a:ext uri="{FF2B5EF4-FFF2-40B4-BE49-F238E27FC236}">
                    <a16:creationId xmlns:a16="http://schemas.microsoft.com/office/drawing/2014/main" id="{ADCBEB25-5F9B-42E5-A197-7333586D74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454900" y="2854325"/>
                <a:ext cx="44450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" name="Line 132">
                <a:extLst>
                  <a:ext uri="{FF2B5EF4-FFF2-40B4-BE49-F238E27FC236}">
                    <a16:creationId xmlns:a16="http://schemas.microsoft.com/office/drawing/2014/main" id="{A3EF14E3-0DE0-4F6E-8441-9F42140784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77125" y="28321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" name="Line 133">
                <a:extLst>
                  <a:ext uri="{FF2B5EF4-FFF2-40B4-BE49-F238E27FC236}">
                    <a16:creationId xmlns:a16="http://schemas.microsoft.com/office/drawing/2014/main" id="{0063C89C-BE0F-4E1D-B129-AB7369D76E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83475" y="28321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7" name="Line 134">
                <a:extLst>
                  <a:ext uri="{FF2B5EF4-FFF2-40B4-BE49-F238E27FC236}">
                    <a16:creationId xmlns:a16="http://schemas.microsoft.com/office/drawing/2014/main" id="{4E70AB63-E032-44FB-BEF7-9668C9D8BC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15225" y="28321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" name="Line 135">
                <a:extLst>
                  <a:ext uri="{FF2B5EF4-FFF2-40B4-BE49-F238E27FC236}">
                    <a16:creationId xmlns:a16="http://schemas.microsoft.com/office/drawing/2014/main" id="{C0485A92-CF79-45E3-82DE-48170A904E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18400" y="28321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" name="Line 136">
                <a:extLst>
                  <a:ext uri="{FF2B5EF4-FFF2-40B4-BE49-F238E27FC236}">
                    <a16:creationId xmlns:a16="http://schemas.microsoft.com/office/drawing/2014/main" id="{4D6C72D0-EAC1-41F5-A297-545496BB3C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56500" y="28321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" name="Line 137">
                <a:extLst>
                  <a:ext uri="{FF2B5EF4-FFF2-40B4-BE49-F238E27FC236}">
                    <a16:creationId xmlns:a16="http://schemas.microsoft.com/office/drawing/2014/main" id="{0163FF4F-02D1-4DFF-9567-C0FDD625AC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642225" y="28321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" name="Line 138">
                <a:extLst>
                  <a:ext uri="{FF2B5EF4-FFF2-40B4-BE49-F238E27FC236}">
                    <a16:creationId xmlns:a16="http://schemas.microsoft.com/office/drawing/2014/main" id="{4C83235F-07A0-4942-B6CA-9A9E7BAA06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683500" y="28321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2" name="Line 139">
                <a:extLst>
                  <a:ext uri="{FF2B5EF4-FFF2-40B4-BE49-F238E27FC236}">
                    <a16:creationId xmlns:a16="http://schemas.microsoft.com/office/drawing/2014/main" id="{616D761A-C5A2-4FBC-9DC2-22445928E2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75588" y="28321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3" name="Line 140">
                <a:extLst>
                  <a:ext uri="{FF2B5EF4-FFF2-40B4-BE49-F238E27FC236}">
                    <a16:creationId xmlns:a16="http://schemas.microsoft.com/office/drawing/2014/main" id="{7084003E-AADA-4AD6-A45F-EAEC34D6BD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126413" y="28321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" name="Line 141">
                <a:extLst>
                  <a:ext uri="{FF2B5EF4-FFF2-40B4-BE49-F238E27FC236}">
                    <a16:creationId xmlns:a16="http://schemas.microsoft.com/office/drawing/2014/main" id="{95AB2F90-2EB2-4FB1-9863-CB47D927D1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777288" y="28321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" name="Line 142">
                <a:extLst>
                  <a:ext uri="{FF2B5EF4-FFF2-40B4-BE49-F238E27FC236}">
                    <a16:creationId xmlns:a16="http://schemas.microsoft.com/office/drawing/2014/main" id="{FE2048AE-F5CF-4962-85E9-F3B555FCD0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796338" y="28321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6" name="Line 143">
                <a:extLst>
                  <a:ext uri="{FF2B5EF4-FFF2-40B4-BE49-F238E27FC236}">
                    <a16:creationId xmlns:a16="http://schemas.microsoft.com/office/drawing/2014/main" id="{911CAFE3-451F-4141-85E7-35C21D353D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8950325" y="2854325"/>
                <a:ext cx="47625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7" name="Line 144">
                <a:extLst>
                  <a:ext uri="{FF2B5EF4-FFF2-40B4-BE49-F238E27FC236}">
                    <a16:creationId xmlns:a16="http://schemas.microsoft.com/office/drawing/2014/main" id="{B979A3AB-54BA-4284-A8F0-8039E643D5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972550" y="28321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</p:grpSp>
      <p:sp>
        <p:nvSpPr>
          <p:cNvPr id="152" name="Rectangle 80">
            <a:extLst>
              <a:ext uri="{FF2B5EF4-FFF2-40B4-BE49-F238E27FC236}">
                <a16:creationId xmlns:a16="http://schemas.microsoft.com/office/drawing/2014/main" id="{83F95A27-1C9A-4E67-93D3-EDDF588B25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81988" y="1579880"/>
            <a:ext cx="77264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en-US" altLang="en-US" sz="900" b="1" dirty="0"/>
              <a:t>Prior LEN + PI</a:t>
            </a:r>
            <a:endParaRPr lang="en-US" altLang="en-US" dirty="0"/>
          </a:p>
        </p:txBody>
      </p:sp>
      <p:sp>
        <p:nvSpPr>
          <p:cNvPr id="154" name="Line 84">
            <a:extLst>
              <a:ext uri="{FF2B5EF4-FFF2-40B4-BE49-F238E27FC236}">
                <a16:creationId xmlns:a16="http://schemas.microsoft.com/office/drawing/2014/main" id="{C2553411-90E3-4742-8F03-941066C9442F}"/>
              </a:ext>
            </a:extLst>
          </p:cNvPr>
          <p:cNvSpPr>
            <a:spLocks noChangeShapeType="1"/>
          </p:cNvSpPr>
          <p:nvPr/>
        </p:nvSpPr>
        <p:spPr bwMode="auto">
          <a:xfrm>
            <a:off x="7923213" y="1652905"/>
            <a:ext cx="304800" cy="0"/>
          </a:xfrm>
          <a:prstGeom prst="line">
            <a:avLst/>
          </a:prstGeom>
          <a:noFill/>
          <a:ln w="1905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56" name="Rectangle 12">
            <a:extLst>
              <a:ext uri="{FF2B5EF4-FFF2-40B4-BE49-F238E27FC236}">
                <a16:creationId xmlns:a16="http://schemas.microsoft.com/office/drawing/2014/main" id="{FEBA80FD-2FF1-4156-B0AA-624E1C7B74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5162" y="4976292"/>
            <a:ext cx="113238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b="1" dirty="0"/>
              <a:t>Number at risk:</a:t>
            </a:r>
          </a:p>
        </p:txBody>
      </p:sp>
      <p:sp>
        <p:nvSpPr>
          <p:cNvPr id="186" name="Rectangle 33">
            <a:extLst>
              <a:ext uri="{FF2B5EF4-FFF2-40B4-BE49-F238E27FC236}">
                <a16:creationId xmlns:a16="http://schemas.microsoft.com/office/drawing/2014/main" id="{5F853EBD-1A59-422A-9D8D-2338CF2BEE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83019" y="4875571"/>
            <a:ext cx="236007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Time Since Enrollment (months)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187" name="Rectangle 34">
            <a:extLst>
              <a:ext uri="{FF2B5EF4-FFF2-40B4-BE49-F238E27FC236}">
                <a16:creationId xmlns:a16="http://schemas.microsoft.com/office/drawing/2014/main" id="{ED4DD22F-F9FF-42C8-94DA-102520CF0E84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080913" y="2874706"/>
            <a:ext cx="219611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Progression-Free Survival (%)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grpSp>
        <p:nvGrpSpPr>
          <p:cNvPr id="153" name="Group 152">
            <a:extLst>
              <a:ext uri="{FF2B5EF4-FFF2-40B4-BE49-F238E27FC236}">
                <a16:creationId xmlns:a16="http://schemas.microsoft.com/office/drawing/2014/main" id="{2107B8D2-8236-42DE-BEF7-05CB9D45BD38}"/>
              </a:ext>
            </a:extLst>
          </p:cNvPr>
          <p:cNvGrpSpPr/>
          <p:nvPr/>
        </p:nvGrpSpPr>
        <p:grpSpPr>
          <a:xfrm>
            <a:off x="3791804" y="3637557"/>
            <a:ext cx="360362" cy="71438"/>
            <a:chOff x="8666163" y="1733025"/>
            <a:chExt cx="360362" cy="71438"/>
          </a:xfrm>
        </p:grpSpPr>
        <p:grpSp>
          <p:nvGrpSpPr>
            <p:cNvPr id="155" name="Group 154">
              <a:extLst>
                <a:ext uri="{FF2B5EF4-FFF2-40B4-BE49-F238E27FC236}">
                  <a16:creationId xmlns:a16="http://schemas.microsoft.com/office/drawing/2014/main" id="{57B3FDEC-3324-4463-A46E-CFE2584DBE5B}"/>
                </a:ext>
              </a:extLst>
            </p:cNvPr>
            <p:cNvGrpSpPr/>
            <p:nvPr/>
          </p:nvGrpSpPr>
          <p:grpSpPr>
            <a:xfrm>
              <a:off x="8731251" y="1733025"/>
              <a:ext cx="228600" cy="71438"/>
              <a:chOff x="9364663" y="1801813"/>
              <a:chExt cx="228600" cy="71438"/>
            </a:xfrm>
          </p:grpSpPr>
          <p:sp>
            <p:nvSpPr>
              <p:cNvPr id="158" name="Line 51">
                <a:extLst>
                  <a:ext uri="{FF2B5EF4-FFF2-40B4-BE49-F238E27FC236}">
                    <a16:creationId xmlns:a16="http://schemas.microsoft.com/office/drawing/2014/main" id="{3AA68DE8-B940-476C-964E-9D97598C0E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4663" y="1801813"/>
                <a:ext cx="0" cy="71438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9" name="Line 52">
                <a:extLst>
                  <a:ext uri="{FF2B5EF4-FFF2-40B4-BE49-F238E27FC236}">
                    <a16:creationId xmlns:a16="http://schemas.microsoft.com/office/drawing/2014/main" id="{2C28B0DE-7E3C-4162-91A9-D316604BAF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480550" y="1801813"/>
                <a:ext cx="0" cy="71438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0" name="Line 53">
                <a:extLst>
                  <a:ext uri="{FF2B5EF4-FFF2-40B4-BE49-F238E27FC236}">
                    <a16:creationId xmlns:a16="http://schemas.microsoft.com/office/drawing/2014/main" id="{3C3BBA2E-8AC4-438B-8CC4-39258F9E03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593263" y="1801813"/>
                <a:ext cx="0" cy="71438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157" name="Line 54">
              <a:extLst>
                <a:ext uri="{FF2B5EF4-FFF2-40B4-BE49-F238E27FC236}">
                  <a16:creationId xmlns:a16="http://schemas.microsoft.com/office/drawing/2014/main" id="{CF924FBE-E278-4ED9-AAE2-40D33E96722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666163" y="1771125"/>
              <a:ext cx="360362" cy="0"/>
            </a:xfrm>
            <a:prstGeom prst="line">
              <a:avLst/>
            </a:pr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graphicFrame>
        <p:nvGraphicFramePr>
          <p:cNvPr id="167" name="Table 166">
            <a:extLst>
              <a:ext uri="{FF2B5EF4-FFF2-40B4-BE49-F238E27FC236}">
                <a16:creationId xmlns:a16="http://schemas.microsoft.com/office/drawing/2014/main" id="{0A1207F0-27FA-4BD9-9CCB-DDE7E29CF9B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63559224"/>
              </p:ext>
            </p:extLst>
          </p:nvPr>
        </p:nvGraphicFramePr>
        <p:xfrm>
          <a:off x="4137718" y="3227904"/>
          <a:ext cx="5143499" cy="577528"/>
        </p:xfrm>
        <a:graphic>
          <a:graphicData uri="http://schemas.openxmlformats.org/drawingml/2006/table">
            <a:tbl>
              <a:tblPr firstRow="1" bandRow="1"/>
              <a:tblGrid>
                <a:gridCol w="1478280">
                  <a:extLst>
                    <a:ext uri="{9D8B030D-6E8A-4147-A177-3AD203B41FA5}">
                      <a16:colId xmlns:a16="http://schemas.microsoft.com/office/drawing/2014/main" val="856427517"/>
                    </a:ext>
                  </a:extLst>
                </a:gridCol>
                <a:gridCol w="1043940">
                  <a:extLst>
                    <a:ext uri="{9D8B030D-6E8A-4147-A177-3AD203B41FA5}">
                      <a16:colId xmlns:a16="http://schemas.microsoft.com/office/drawing/2014/main" val="4179246454"/>
                    </a:ext>
                  </a:extLst>
                </a:gridCol>
                <a:gridCol w="2621279">
                  <a:extLst>
                    <a:ext uri="{9D8B030D-6E8A-4147-A177-3AD203B41FA5}">
                      <a16:colId xmlns:a16="http://schemas.microsoft.com/office/drawing/2014/main" val="3961210330"/>
                    </a:ext>
                  </a:extLst>
                </a:gridCol>
              </a:tblGrid>
              <a:tr h="301388"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700" marR="68700" marT="28388" marB="28388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1pPr>
                      <a:lvl2pPr marL="290629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2pPr>
                      <a:lvl3pPr marL="581260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3pPr>
                      <a:lvl4pPr marL="871889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4pPr>
                      <a:lvl5pPr marL="1162518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5pPr>
                      <a:lvl6pPr marL="145314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6pPr>
                      <a:lvl7pPr marL="1743778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7pPr>
                      <a:lvl8pPr marL="203440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8pPr>
                      <a:lvl9pPr marL="232503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9pPr>
                    </a:lstStyle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vents</a:t>
                      </a:r>
                    </a:p>
                  </a:txBody>
                  <a:tcPr marL="68700" marR="68700" marT="28388" marB="28388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1pPr>
                      <a:lvl2pPr marL="290629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2pPr>
                      <a:lvl3pPr marL="581260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3pPr>
                      <a:lvl4pPr marL="871889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4pPr>
                      <a:lvl5pPr marL="1162518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5pPr>
                      <a:lvl6pPr marL="145314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6pPr>
                      <a:lvl7pPr marL="1743778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7pPr>
                      <a:lvl8pPr marL="203440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8pPr>
                      <a:lvl9pPr marL="232503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9pPr>
                    </a:lstStyle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PFS, months</a:t>
                      </a:r>
                    </a:p>
                  </a:txBody>
                  <a:tcPr marL="68700" marR="68700" marT="28388" marB="28388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4528241"/>
                  </a:ext>
                </a:extLst>
              </a:tr>
              <a:tr h="276140">
                <a:tc>
                  <a:txBody>
                    <a:bodyPr/>
                    <a:lstStyle/>
                    <a:p>
                      <a:pPr algn="l"/>
                      <a:r>
                        <a:rPr lang="en-US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or LEN + PI</a:t>
                      </a:r>
                    </a:p>
                  </a:txBody>
                  <a:tcPr marL="68700" marR="68700" marT="28388" marB="2838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1pPr>
                      <a:lvl2pPr marL="290629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2pPr>
                      <a:lvl3pPr marL="581260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3pPr>
                      <a:lvl4pPr marL="871889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4pPr>
                      <a:lvl5pPr marL="1162518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5pPr>
                      <a:lvl6pPr marL="145314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6pPr>
                      <a:lvl7pPr marL="1743778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7pPr>
                      <a:lvl8pPr marL="203440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8pPr>
                      <a:lvl9pPr marL="232503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9pPr>
                    </a:lstStyle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/89</a:t>
                      </a:r>
                    </a:p>
                  </a:txBody>
                  <a:tcPr marL="68700" marR="68700" marT="28388" marB="2838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1pPr>
                      <a:lvl2pPr marL="290629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2pPr>
                      <a:lvl3pPr marL="581260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3pPr>
                      <a:lvl4pPr marL="871889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4pPr>
                      <a:lvl5pPr marL="1162518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5pPr>
                      <a:lvl6pPr marL="145314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6pPr>
                      <a:lvl7pPr marL="1743778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7pPr>
                      <a:lvl8pPr marL="203440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8pPr>
                      <a:lvl9pPr marL="232503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9pPr>
                    </a:lstStyle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</a:t>
                      </a:r>
                    </a:p>
                  </a:txBody>
                  <a:tcPr marL="68700" marR="68700" marT="28388" marB="28388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7030826"/>
                  </a:ext>
                </a:extLst>
              </a:tr>
            </a:tbl>
          </a:graphicData>
        </a:graphic>
      </p:graphicFrame>
      <p:sp>
        <p:nvSpPr>
          <p:cNvPr id="161" name="TextBox 160">
            <a:extLst>
              <a:ext uri="{FF2B5EF4-FFF2-40B4-BE49-F238E27FC236}">
                <a16:creationId xmlns:a16="http://schemas.microsoft.com/office/drawing/2014/main" id="{29D4EE76-B58A-42EE-A10F-7195F89F2242}"/>
              </a:ext>
            </a:extLst>
          </p:cNvPr>
          <p:cNvSpPr txBox="1"/>
          <p:nvPr/>
        </p:nvSpPr>
        <p:spPr>
          <a:xfrm>
            <a:off x="1545631" y="6164826"/>
            <a:ext cx="9114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EN, lenalidomide; NE, not estimable; PFS, progression-free survival; PI, proteasome inhibitor.</a:t>
            </a:r>
          </a:p>
        </p:txBody>
      </p:sp>
    </p:spTree>
    <p:extLst>
      <p:ext uri="{BB962C8B-B14F-4D97-AF65-F5344CB8AC3E}">
        <p14:creationId xmlns:p14="http://schemas.microsoft.com/office/powerpoint/2010/main" val="2367621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7</TotalTime>
  <Words>87</Words>
  <Application>Microsoft Office PowerPoint</Application>
  <PresentationFormat>Widescreen</PresentationFormat>
  <Paragraphs>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wn Vahabzadeh, PharmD (MTM)</dc:creator>
  <cp:lastModifiedBy>Shawn Vahabzadeh, PharmD (MTM)</cp:lastModifiedBy>
  <cp:revision>84</cp:revision>
  <dcterms:created xsi:type="dcterms:W3CDTF">2018-07-18T19:14:30Z</dcterms:created>
  <dcterms:modified xsi:type="dcterms:W3CDTF">2020-05-01T19:40:52Z</dcterms:modified>
</cp:coreProperties>
</file>